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1FA7A-B38C-4076-BF77-7269D689A3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AAD55-426B-4A50-95E8-C78008F906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A09ED-C8FB-4187-B3BE-DB8A55450C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86878-8531-4541-A275-B3824F4DFD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A91E9-C933-4078-92BC-5521B1829F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53523-A4D8-48D2-883A-E817CC03AD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64365-D544-4D8A-96B9-9E80DB4C1C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3BFC56-7498-4764-841A-F39CA736C5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8DFE7-6591-4F7F-B293-06D0D042D0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143CB-E258-4648-87B2-7BF2CEDD79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A42DC-FBDF-4F14-BDC3-9E5AB2B456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7BD48-1FA6-4993-A844-A4283B9A93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19533B-B835-46E4-848C-A7D4ECAD0DC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95280" y="136440"/>
            <a:ext cx="4213080" cy="2787840"/>
            <a:chOff x="395280" y="136440"/>
            <a:chExt cx="4213080" cy="2787840"/>
          </a:xfrm>
        </p:grpSpPr>
        <p:pic>
          <p:nvPicPr>
            <p:cNvPr id="42" name="Picture 4" descr="cls"/>
            <p:cNvPicPr/>
            <p:nvPr/>
          </p:nvPicPr>
          <p:blipFill>
            <a:blip r:embed="rId1"/>
            <a:srcRect l="0" t="8552" r="0" b="5716"/>
            <a:stretch/>
          </p:blipFill>
          <p:spPr>
            <a:xfrm>
              <a:off x="395280" y="352440"/>
              <a:ext cx="3600360" cy="2571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6"/>
            <p:cNvSpPr/>
            <p:nvPr/>
          </p:nvSpPr>
          <p:spPr>
            <a:xfrm>
              <a:off x="971280" y="136440"/>
              <a:ext cx="3637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IL2 – Down-regulated Gen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" name="Text Box 6"/>
          <p:cNvSpPr/>
          <p:nvPr/>
        </p:nvSpPr>
        <p:spPr>
          <a:xfrm>
            <a:off x="5003640" y="189000"/>
            <a:ext cx="363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PS – Down-regul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2"/>
          <a:srcRect l="0" t="9440" r="3870" b="7176"/>
          <a:stretch/>
        </p:blipFill>
        <p:spPr>
          <a:xfrm>
            <a:off x="539640" y="3645000"/>
            <a:ext cx="3056040" cy="264636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900000" y="3357720"/>
            <a:ext cx="288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NF - Down-regul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3"/>
          <a:srcRect l="0" t="10353" r="0" b="6810"/>
          <a:stretch/>
        </p:blipFill>
        <p:spPr>
          <a:xfrm>
            <a:off x="4572000" y="3645000"/>
            <a:ext cx="3241800" cy="268272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5076720" y="3357720"/>
            <a:ext cx="288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FNg - Down-regul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4"/>
          <a:srcRect l="0" t="9440" r="3870" b="7176"/>
          <a:stretch/>
        </p:blipFill>
        <p:spPr>
          <a:xfrm>
            <a:off x="4572000" y="404640"/>
            <a:ext cx="3095640" cy="268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"/>
          <p:cNvGrpSpPr/>
          <p:nvPr/>
        </p:nvGrpSpPr>
        <p:grpSpPr>
          <a:xfrm>
            <a:off x="274680" y="217440"/>
            <a:ext cx="3792600" cy="3211560"/>
            <a:chOff x="274680" y="217440"/>
            <a:chExt cx="3792600" cy="3211560"/>
          </a:xfrm>
        </p:grpSpPr>
        <p:pic>
          <p:nvPicPr>
            <p:cNvPr id="51" name="Picture 4" descr="cls"/>
            <p:cNvPicPr/>
            <p:nvPr/>
          </p:nvPicPr>
          <p:blipFill>
            <a:blip r:embed="rId1"/>
            <a:srcRect l="0" t="9710" r="0" b="7176"/>
            <a:stretch/>
          </p:blipFill>
          <p:spPr>
            <a:xfrm>
              <a:off x="274680" y="433440"/>
              <a:ext cx="3535200" cy="2995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 Box 6"/>
            <p:cNvSpPr/>
            <p:nvPr/>
          </p:nvSpPr>
          <p:spPr>
            <a:xfrm>
              <a:off x="924120" y="217440"/>
              <a:ext cx="314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DGF – Down-regulated Gen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3" name="" descr=""/>
          <p:cNvPicPr/>
          <p:nvPr/>
        </p:nvPicPr>
        <p:blipFill>
          <a:blip r:embed="rId2"/>
          <a:srcRect l="0" t="8083" r="3200" b="6303"/>
          <a:stretch/>
        </p:blipFill>
        <p:spPr>
          <a:xfrm>
            <a:off x="4572000" y="384120"/>
            <a:ext cx="3529080" cy="311616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5076720" y="244440"/>
            <a:ext cx="288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PA - Down-regul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3"/>
          <a:srcRect l="0" t="9440" r="2750" b="7176"/>
          <a:stretch/>
        </p:blipFill>
        <p:spPr>
          <a:xfrm>
            <a:off x="539640" y="3860640"/>
            <a:ext cx="3056040" cy="261648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684360" y="3645000"/>
            <a:ext cx="316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nisomycin - Down-regul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4"/>
          <a:srcRect l="0" t="9750" r="2756" b="6748"/>
          <a:stretch/>
        </p:blipFill>
        <p:spPr>
          <a:xfrm>
            <a:off x="4788000" y="3933720"/>
            <a:ext cx="3024000" cy="259416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5005440" y="3645000"/>
            <a:ext cx="316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rum - Down-regul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6T12:10:21Z</dcterms:created>
  <dc:creator>user</dc:creator>
  <dc:description/>
  <dc:language>en-US</dc:language>
  <cp:lastModifiedBy>user</cp:lastModifiedBy>
  <dcterms:modified xsi:type="dcterms:W3CDTF">2010-04-15T10:52:50Z</dcterms:modified>
  <cp:revision>84</cp:revision>
  <dc:subject/>
  <dc:title>Slide 1</dc:title>
</cp:coreProperties>
</file>